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4/05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5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5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5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5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5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5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4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5536" y="5448706"/>
            <a:ext cx="684076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heu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172-x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Summary of the clinical features and pathophysiology of skeletal fragility in diabetes</a:t>
            </a:r>
            <a:endParaRPr lang="en-GB" sz="1800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7DC0A42-7C2C-5672-0548-FF07F122180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0032" y="908720"/>
            <a:ext cx="8104416" cy="48965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95536" y="5828491"/>
            <a:ext cx="7128792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heu et al (2024) Diabetologia DOI 10.1007/s00125-024-06172-x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Optimising the management of skeletal fragility in diabete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82F3BDA-A841-F85D-9BA0-B618071941F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11760" y="764704"/>
            <a:ext cx="4349167" cy="5259854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1</Words>
  <Application>Microsoft Office PowerPoint</Application>
  <PresentationFormat>On-screen Show (4:3)</PresentationFormat>
  <Paragraphs>1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8</cp:revision>
  <dcterms:created xsi:type="dcterms:W3CDTF">2016-06-15T12:53:43Z</dcterms:created>
  <dcterms:modified xsi:type="dcterms:W3CDTF">2024-05-14T07:35:03Z</dcterms:modified>
</cp:coreProperties>
</file>